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9" autoAdjust="0"/>
    <p:restoredTop sz="94660"/>
  </p:normalViewPr>
  <p:slideViewPr>
    <p:cSldViewPr snapToGrid="0">
      <p:cViewPr varScale="1">
        <p:scale>
          <a:sx n="51" d="100"/>
          <a:sy n="51" d="100"/>
        </p:scale>
        <p:origin x="242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I:\&#12414;&#12427;&#12387;&#12392;&#21454;&#32013;\&#12385;&#12423;&#12371;&#12387;&#12392;\&#35542;&#25991;\3_indole%20lactic%20acid%20&#29987;&#29983;\ILA_IAld_IAA_IP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NULL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NULL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61537037037037"/>
          <c:y val="5.2288194444444443E-2"/>
          <c:w val="0.86751425925925929"/>
          <c:h val="0.391607291666666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9株'!$F$4</c:f>
              <c:strCache>
                <c:ptCount val="1"/>
                <c:pt idx="0">
                  <c:v>IAld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62C-45E6-B0E1-D5A43EAD8586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62C-45E6-B0E1-D5A43EAD8586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62C-45E6-B0E1-D5A43EAD8586}"/>
              </c:ext>
            </c:extLst>
          </c:dPt>
          <c:dPt>
            <c:idx val="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62C-45E6-B0E1-D5A43EAD8586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62C-45E6-B0E1-D5A43EAD8586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62C-45E6-B0E1-D5A43EAD8586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862C-45E6-B0E1-D5A43EAD8586}"/>
              </c:ext>
            </c:extLst>
          </c:dPt>
          <c:dPt>
            <c:idx val="8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862C-45E6-B0E1-D5A43EAD8586}"/>
              </c:ext>
            </c:extLst>
          </c:dPt>
          <c:dPt>
            <c:idx val="9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862C-45E6-B0E1-D5A43EAD8586}"/>
              </c:ext>
            </c:extLst>
          </c:dPt>
          <c:dPt>
            <c:idx val="10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862C-45E6-B0E1-D5A43EAD8586}"/>
              </c:ext>
            </c:extLst>
          </c:dPt>
          <c:dPt>
            <c:idx val="11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862C-45E6-B0E1-D5A43EAD8586}"/>
              </c:ext>
            </c:extLst>
          </c:dPt>
          <c:dPt>
            <c:idx val="12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862C-45E6-B0E1-D5A43EAD8586}"/>
              </c:ext>
            </c:extLst>
          </c:dPt>
          <c:dPt>
            <c:idx val="13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862C-45E6-B0E1-D5A43EAD8586}"/>
              </c:ext>
            </c:extLst>
          </c:dPt>
          <c:dPt>
            <c:idx val="14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862C-45E6-B0E1-D5A43EAD8586}"/>
              </c:ext>
            </c:extLst>
          </c:dPt>
          <c:dPt>
            <c:idx val="15"/>
            <c:invertIfNegative val="0"/>
            <c:bubble3D val="0"/>
            <c:spPr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862C-45E6-B0E1-D5A43EAD8586}"/>
              </c:ext>
            </c:extLst>
          </c:dPt>
          <c:dPt>
            <c:idx val="16"/>
            <c:invertIfNegative val="0"/>
            <c:bubble3D val="0"/>
            <c:spPr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862C-45E6-B0E1-D5A43EAD8586}"/>
              </c:ext>
            </c:extLst>
          </c:dPt>
          <c:dPt>
            <c:idx val="17"/>
            <c:invertIfNegative val="0"/>
            <c:bubble3D val="0"/>
            <c:spPr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862C-45E6-B0E1-D5A43EAD8586}"/>
              </c:ext>
            </c:extLst>
          </c:dPt>
          <c:dPt>
            <c:idx val="18"/>
            <c:invertIfNegative val="0"/>
            <c:bubble3D val="0"/>
            <c:spPr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862C-45E6-B0E1-D5A43EAD8586}"/>
              </c:ext>
            </c:extLst>
          </c:dPt>
          <c:dPt>
            <c:idx val="19"/>
            <c:invertIfNegative val="0"/>
            <c:bubble3D val="0"/>
            <c:spPr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862C-45E6-B0E1-D5A43EAD8586}"/>
              </c:ext>
            </c:extLst>
          </c:dPt>
          <c:errBars>
            <c:errBarType val="both"/>
            <c:errValType val="cust"/>
            <c:noEndCap val="0"/>
            <c:plus>
              <c:numRef>
                <c:f>'19株'!$J$5:$J$24</c:f>
                <c:numCache>
                  <c:formatCode>General</c:formatCode>
                  <c:ptCount val="20"/>
                  <c:pt idx="0">
                    <c:v>6.9521129507356898</c:v>
                  </c:pt>
                  <c:pt idx="1">
                    <c:v>7.5082610367070259</c:v>
                  </c:pt>
                  <c:pt idx="2">
                    <c:v>2.5785245556793899</c:v>
                  </c:pt>
                  <c:pt idx="3">
                    <c:v>1.1636671683835396</c:v>
                  </c:pt>
                  <c:pt idx="4">
                    <c:v>0.63607386221339646</c:v>
                  </c:pt>
                  <c:pt idx="5">
                    <c:v>2.5913049811633071</c:v>
                  </c:pt>
                  <c:pt idx="6">
                    <c:v>3.2449028834061084</c:v>
                  </c:pt>
                  <c:pt idx="7">
                    <c:v>3.4563942797833547</c:v>
                  </c:pt>
                  <c:pt idx="8">
                    <c:v>2.3724592779469278</c:v>
                  </c:pt>
                  <c:pt idx="9">
                    <c:v>2.8032135853099311</c:v>
                  </c:pt>
                  <c:pt idx="10">
                    <c:v>2.0701247736450674</c:v>
                  </c:pt>
                  <c:pt idx="11">
                    <c:v>1.6797909500989001</c:v>
                  </c:pt>
                  <c:pt idx="12">
                    <c:v>6.7954043961442752</c:v>
                  </c:pt>
                  <c:pt idx="13">
                    <c:v>1.7740895543095629</c:v>
                  </c:pt>
                  <c:pt idx="14">
                    <c:v>0.67260291543563722</c:v>
                  </c:pt>
                  <c:pt idx="15">
                    <c:v>0.66619282443609695</c:v>
                  </c:pt>
                  <c:pt idx="16">
                    <c:v>4.3681513127010829</c:v>
                  </c:pt>
                  <c:pt idx="17">
                    <c:v>1.0069384292922388</c:v>
                  </c:pt>
                  <c:pt idx="18">
                    <c:v>1.0551783060561761</c:v>
                  </c:pt>
                  <c:pt idx="19">
                    <c:v>2.0385936884913431</c:v>
                  </c:pt>
                </c:numCache>
              </c:numRef>
            </c:plus>
            <c:minus>
              <c:numRef>
                <c:f>'19株'!$J$5:$J$24</c:f>
                <c:numCache>
                  <c:formatCode>General</c:formatCode>
                  <c:ptCount val="20"/>
                  <c:pt idx="0">
                    <c:v>6.9521129507356898</c:v>
                  </c:pt>
                  <c:pt idx="1">
                    <c:v>7.5082610367070259</c:v>
                  </c:pt>
                  <c:pt idx="2">
                    <c:v>2.5785245556793899</c:v>
                  </c:pt>
                  <c:pt idx="3">
                    <c:v>1.1636671683835396</c:v>
                  </c:pt>
                  <c:pt idx="4">
                    <c:v>0.63607386221339646</c:v>
                  </c:pt>
                  <c:pt idx="5">
                    <c:v>2.5913049811633071</c:v>
                  </c:pt>
                  <c:pt idx="6">
                    <c:v>3.2449028834061084</c:v>
                  </c:pt>
                  <c:pt idx="7">
                    <c:v>3.4563942797833547</c:v>
                  </c:pt>
                  <c:pt idx="8">
                    <c:v>2.3724592779469278</c:v>
                  </c:pt>
                  <c:pt idx="9">
                    <c:v>2.8032135853099311</c:v>
                  </c:pt>
                  <c:pt idx="10">
                    <c:v>2.0701247736450674</c:v>
                  </c:pt>
                  <c:pt idx="11">
                    <c:v>1.6797909500989001</c:v>
                  </c:pt>
                  <c:pt idx="12">
                    <c:v>6.7954043961442752</c:v>
                  </c:pt>
                  <c:pt idx="13">
                    <c:v>1.7740895543095629</c:v>
                  </c:pt>
                  <c:pt idx="14">
                    <c:v>0.67260291543563722</c:v>
                  </c:pt>
                  <c:pt idx="15">
                    <c:v>0.66619282443609695</c:v>
                  </c:pt>
                  <c:pt idx="16">
                    <c:v>4.3681513127010829</c:v>
                  </c:pt>
                  <c:pt idx="17">
                    <c:v>1.0069384292922388</c:v>
                  </c:pt>
                  <c:pt idx="18">
                    <c:v>1.0551783060561761</c:v>
                  </c:pt>
                  <c:pt idx="19">
                    <c:v>2.0385936884913431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19株'!$E$5:$E$24</c:f>
              <c:strCache>
                <c:ptCount val="20"/>
                <c:pt idx="0">
                  <c:v>MRS</c:v>
                </c:pt>
                <c:pt idx="1">
                  <c:v>ATCC29521T</c:v>
                </c:pt>
                <c:pt idx="2">
                  <c:v>NITE BP-02429</c:v>
                </c:pt>
                <c:pt idx="3">
                  <c:v>NITE BP-02431</c:v>
                </c:pt>
                <c:pt idx="4">
                  <c:v>ATCC15700T</c:v>
                </c:pt>
                <c:pt idx="5">
                  <c:v>FERM BP-11175</c:v>
                </c:pt>
                <c:pt idx="6">
                  <c:v>LMG 23729</c:v>
                </c:pt>
                <c:pt idx="7">
                  <c:v>ATCC15697T</c:v>
                </c:pt>
                <c:pt idx="8">
                  <c:v>LMG 23728</c:v>
                </c:pt>
                <c:pt idx="9">
                  <c:v>ATCC15707T</c:v>
                </c:pt>
                <c:pt idx="10">
                  <c:v>ATCC BAA-999T</c:v>
                </c:pt>
                <c:pt idx="11">
                  <c:v>ATCC15703T</c:v>
                </c:pt>
                <c:pt idx="12">
                  <c:v>ATCC27535T</c:v>
                </c:pt>
                <c:pt idx="13">
                  <c:v>DSM20436T</c:v>
                </c:pt>
                <c:pt idx="14">
                  <c:v>ATCC27919T</c:v>
                </c:pt>
                <c:pt idx="15">
                  <c:v>DSM10140T</c:v>
                </c:pt>
                <c:pt idx="16">
                  <c:v>ATCC25527T</c:v>
                </c:pt>
                <c:pt idx="17">
                  <c:v>JCM5820T</c:v>
                </c:pt>
                <c:pt idx="18">
                  <c:v>ATCC25526T</c:v>
                </c:pt>
                <c:pt idx="19">
                  <c:v>ATCC 25525T</c:v>
                </c:pt>
              </c:strCache>
            </c:strRef>
          </c:cat>
          <c:val>
            <c:numRef>
              <c:f>'19株'!$F$5:$F$24</c:f>
              <c:numCache>
                <c:formatCode>0.00</c:formatCode>
                <c:ptCount val="20"/>
                <c:pt idx="0">
                  <c:v>127.93161869263059</c:v>
                </c:pt>
                <c:pt idx="1">
                  <c:v>137.42292999541178</c:v>
                </c:pt>
                <c:pt idx="2">
                  <c:v>128.26042860714881</c:v>
                </c:pt>
                <c:pt idx="3">
                  <c:v>119.1573984199555</c:v>
                </c:pt>
                <c:pt idx="4">
                  <c:v>128.61114056745947</c:v>
                </c:pt>
                <c:pt idx="5">
                  <c:v>127.1128665269066</c:v>
                </c:pt>
                <c:pt idx="6">
                  <c:v>130.69141700479292</c:v>
                </c:pt>
                <c:pt idx="7">
                  <c:v>139.229368230966</c:v>
                </c:pt>
                <c:pt idx="8">
                  <c:v>127.02716283424806</c:v>
                </c:pt>
                <c:pt idx="9">
                  <c:v>132.41966905794885</c:v>
                </c:pt>
                <c:pt idx="10">
                  <c:v>134.97423185772527</c:v>
                </c:pt>
                <c:pt idx="11">
                  <c:v>136.53263045342197</c:v>
                </c:pt>
                <c:pt idx="12">
                  <c:v>124.48437992308075</c:v>
                </c:pt>
                <c:pt idx="13">
                  <c:v>141.62991701737747</c:v>
                </c:pt>
                <c:pt idx="14">
                  <c:v>136.11019241533995</c:v>
                </c:pt>
                <c:pt idx="15">
                  <c:v>133.0749938351039</c:v>
                </c:pt>
                <c:pt idx="16">
                  <c:v>134.44458744677053</c:v>
                </c:pt>
                <c:pt idx="17">
                  <c:v>143.64943013927655</c:v>
                </c:pt>
                <c:pt idx="18">
                  <c:v>111.51332833754179</c:v>
                </c:pt>
                <c:pt idx="19">
                  <c:v>139.791815008968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862C-45E6-B0E1-D5A43EAD85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-27"/>
        <c:axId val="511256288"/>
        <c:axId val="425113976"/>
      </c:barChart>
      <c:catAx>
        <c:axId val="5112562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ja-JP"/>
          </a:p>
        </c:txPr>
        <c:crossAx val="425113976"/>
        <c:crosses val="autoZero"/>
        <c:auto val="1"/>
        <c:lblAlgn val="ctr"/>
        <c:lblOffset val="100"/>
        <c:noMultiLvlLbl val="0"/>
      </c:catAx>
      <c:valAx>
        <c:axId val="425113976"/>
        <c:scaling>
          <c:orientation val="minMax"/>
          <c:max val="1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Arial Narrow" panose="020B0606020202030204" pitchFamily="34" charset="0"/>
                  </a:rPr>
                  <a:t>ng/ml</a:t>
                </a:r>
                <a:endParaRPr lang="ja-JP" altLang="en-US" sz="1200" b="1">
                  <a:solidFill>
                    <a:schemeClr val="tx1"/>
                  </a:solidFill>
                  <a:latin typeface="Arial Narrow" panose="020B060602020203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ja-JP"/>
          </a:p>
        </c:txPr>
        <c:crossAx val="51125628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649796296296296"/>
          <c:y val="8.3661111111111117E-2"/>
          <c:w val="0.86763166666666669"/>
          <c:h val="0.809071111111111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G$4</c:f>
              <c:strCache>
                <c:ptCount val="1"/>
                <c:pt idx="0">
                  <c:v>IAA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EE3-48BD-AEEB-CF5765B9BDEA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EE3-48BD-AEEB-CF5765B9BDEA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EE3-48BD-AEEB-CF5765B9BDEA}"/>
              </c:ext>
            </c:extLst>
          </c:dPt>
          <c:dPt>
            <c:idx val="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EE3-48BD-AEEB-CF5765B9BDEA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EE3-48BD-AEEB-CF5765B9BDEA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EE3-48BD-AEEB-CF5765B9BDEA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EE3-48BD-AEEB-CF5765B9BDEA}"/>
              </c:ext>
            </c:extLst>
          </c:dPt>
          <c:dPt>
            <c:idx val="8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EE3-48BD-AEEB-CF5765B9BDEA}"/>
              </c:ext>
            </c:extLst>
          </c:dPt>
          <c:dPt>
            <c:idx val="9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EE3-48BD-AEEB-CF5765B9BDEA}"/>
              </c:ext>
            </c:extLst>
          </c:dPt>
          <c:dPt>
            <c:idx val="10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9EE3-48BD-AEEB-CF5765B9BDEA}"/>
              </c:ext>
            </c:extLst>
          </c:dPt>
          <c:dPt>
            <c:idx val="11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9EE3-48BD-AEEB-CF5765B9BDEA}"/>
              </c:ext>
            </c:extLst>
          </c:dPt>
          <c:dPt>
            <c:idx val="12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9EE3-48BD-AEEB-CF5765B9BDEA}"/>
              </c:ext>
            </c:extLst>
          </c:dPt>
          <c:dPt>
            <c:idx val="13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9EE3-48BD-AEEB-CF5765B9BDEA}"/>
              </c:ext>
            </c:extLst>
          </c:dPt>
          <c:dPt>
            <c:idx val="14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9EE3-48BD-AEEB-CF5765B9BDEA}"/>
              </c:ext>
            </c:extLst>
          </c:dPt>
          <c:dPt>
            <c:idx val="15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9EE3-48BD-AEEB-CF5765B9BDEA}"/>
              </c:ext>
            </c:extLst>
          </c:dPt>
          <c:dPt>
            <c:idx val="16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9EE3-48BD-AEEB-CF5765B9BDEA}"/>
              </c:ext>
            </c:extLst>
          </c:dPt>
          <c:dPt>
            <c:idx val="17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9EE3-48BD-AEEB-CF5765B9BDEA}"/>
              </c:ext>
            </c:extLst>
          </c:dPt>
          <c:dPt>
            <c:idx val="18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9EE3-48BD-AEEB-CF5765B9BDEA}"/>
              </c:ext>
            </c:extLst>
          </c:dPt>
          <c:dPt>
            <c:idx val="19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9EE3-48BD-AEEB-CF5765B9BDEA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K$5:$K$24</c:f>
                <c:numCache>
                  <c:formatCode>General</c:formatCode>
                  <c:ptCount val="20"/>
                  <c:pt idx="0">
                    <c:v>10.853753722618462</c:v>
                  </c:pt>
                  <c:pt idx="1">
                    <c:v>6.3378420827548263</c:v>
                  </c:pt>
                  <c:pt idx="2">
                    <c:v>2.9332568843551896</c:v>
                  </c:pt>
                  <c:pt idx="3">
                    <c:v>1.7866091720168262</c:v>
                  </c:pt>
                  <c:pt idx="4">
                    <c:v>1.8678574377729091</c:v>
                  </c:pt>
                  <c:pt idx="5">
                    <c:v>2.9036459293860299</c:v>
                  </c:pt>
                  <c:pt idx="6">
                    <c:v>5.9999156725993874</c:v>
                  </c:pt>
                  <c:pt idx="7">
                    <c:v>1.7372169417547469</c:v>
                  </c:pt>
                  <c:pt idx="8">
                    <c:v>2.5088472198508511</c:v>
                  </c:pt>
                  <c:pt idx="9">
                    <c:v>4.3927919790197159</c:v>
                  </c:pt>
                  <c:pt idx="10">
                    <c:v>3.1160984494257495</c:v>
                  </c:pt>
                  <c:pt idx="11">
                    <c:v>4.5037770626578908</c:v>
                  </c:pt>
                  <c:pt idx="12">
                    <c:v>8.1917111485354948</c:v>
                  </c:pt>
                  <c:pt idx="13">
                    <c:v>5.0302634433879776</c:v>
                  </c:pt>
                  <c:pt idx="14">
                    <c:v>4.036332931009122</c:v>
                  </c:pt>
                  <c:pt idx="15">
                    <c:v>4.5063177084547918</c:v>
                  </c:pt>
                  <c:pt idx="16">
                    <c:v>1.706532508465592</c:v>
                  </c:pt>
                  <c:pt idx="17">
                    <c:v>0.72868166683328717</c:v>
                  </c:pt>
                  <c:pt idx="18">
                    <c:v>4.7265598729787985</c:v>
                  </c:pt>
                  <c:pt idx="19">
                    <c:v>3.9512228277366228</c:v>
                  </c:pt>
                </c:numCache>
              </c:numRef>
            </c:plus>
            <c:minus>
              <c:numRef>
                <c:f>Sheet2!$K$5:$K$24</c:f>
                <c:numCache>
                  <c:formatCode>General</c:formatCode>
                  <c:ptCount val="20"/>
                  <c:pt idx="0">
                    <c:v>10.853753722618462</c:v>
                  </c:pt>
                  <c:pt idx="1">
                    <c:v>6.3378420827548263</c:v>
                  </c:pt>
                  <c:pt idx="2">
                    <c:v>2.9332568843551896</c:v>
                  </c:pt>
                  <c:pt idx="3">
                    <c:v>1.7866091720168262</c:v>
                  </c:pt>
                  <c:pt idx="4">
                    <c:v>1.8678574377729091</c:v>
                  </c:pt>
                  <c:pt idx="5">
                    <c:v>2.9036459293860299</c:v>
                  </c:pt>
                  <c:pt idx="6">
                    <c:v>5.9999156725993874</c:v>
                  </c:pt>
                  <c:pt idx="7">
                    <c:v>1.7372169417547469</c:v>
                  </c:pt>
                  <c:pt idx="8">
                    <c:v>2.5088472198508511</c:v>
                  </c:pt>
                  <c:pt idx="9">
                    <c:v>4.3927919790197159</c:v>
                  </c:pt>
                  <c:pt idx="10">
                    <c:v>3.1160984494257495</c:v>
                  </c:pt>
                  <c:pt idx="11">
                    <c:v>4.5037770626578908</c:v>
                  </c:pt>
                  <c:pt idx="12">
                    <c:v>8.1917111485354948</c:v>
                  </c:pt>
                  <c:pt idx="13">
                    <c:v>5.0302634433879776</c:v>
                  </c:pt>
                  <c:pt idx="14">
                    <c:v>4.036332931009122</c:v>
                  </c:pt>
                  <c:pt idx="15">
                    <c:v>4.5063177084547918</c:v>
                  </c:pt>
                  <c:pt idx="16">
                    <c:v>1.706532508465592</c:v>
                  </c:pt>
                  <c:pt idx="17">
                    <c:v>0.72868166683328717</c:v>
                  </c:pt>
                  <c:pt idx="18">
                    <c:v>4.7265598729787985</c:v>
                  </c:pt>
                  <c:pt idx="19">
                    <c:v>3.9512228277366228</c:v>
                  </c:pt>
                </c:numCache>
              </c:numRef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2!$N$5:$N$24</c:f>
              <c:numCache>
                <c:formatCode>General</c:formatCode>
                <c:ptCount val="20"/>
              </c:numCache>
            </c:numRef>
          </c:cat>
          <c:val>
            <c:numRef>
              <c:f>Sheet2!$G$5:$G$24</c:f>
              <c:numCache>
                <c:formatCode>0.00</c:formatCode>
                <c:ptCount val="20"/>
                <c:pt idx="0">
                  <c:v>19.874400380898976</c:v>
                </c:pt>
                <c:pt idx="1">
                  <c:v>17.498595086415762</c:v>
                </c:pt>
                <c:pt idx="2">
                  <c:v>15.066837929994467</c:v>
                </c:pt>
                <c:pt idx="3">
                  <c:v>16.347873334872347</c:v>
                </c:pt>
                <c:pt idx="4">
                  <c:v>14.541134558365131</c:v>
                </c:pt>
                <c:pt idx="5">
                  <c:v>15.184864464100759</c:v>
                </c:pt>
                <c:pt idx="6">
                  <c:v>18.361240698144282</c:v>
                </c:pt>
                <c:pt idx="7">
                  <c:v>17.45053074319387</c:v>
                </c:pt>
                <c:pt idx="8">
                  <c:v>15.914515817912838</c:v>
                </c:pt>
                <c:pt idx="9">
                  <c:v>16.264861379669046</c:v>
                </c:pt>
                <c:pt idx="10">
                  <c:v>15.322840143035148</c:v>
                </c:pt>
                <c:pt idx="11">
                  <c:v>15.388676623110513</c:v>
                </c:pt>
                <c:pt idx="12">
                  <c:v>13.472878379589346</c:v>
                </c:pt>
                <c:pt idx="13">
                  <c:v>20.670696435744603</c:v>
                </c:pt>
                <c:pt idx="14">
                  <c:v>17.216641463794481</c:v>
                </c:pt>
                <c:pt idx="15">
                  <c:v>22.17325090911757</c:v>
                </c:pt>
                <c:pt idx="16">
                  <c:v>20.295735905210929</c:v>
                </c:pt>
                <c:pt idx="17">
                  <c:v>16.156672908774052</c:v>
                </c:pt>
                <c:pt idx="18">
                  <c:v>17.266494369213085</c:v>
                </c:pt>
                <c:pt idx="19">
                  <c:v>24.8552601716435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9EE3-48BD-AEEB-CF5765B9BD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-27"/>
        <c:axId val="425114760"/>
        <c:axId val="412031408"/>
      </c:barChart>
      <c:catAx>
        <c:axId val="425114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ja-JP"/>
          </a:p>
        </c:txPr>
        <c:crossAx val="412031408"/>
        <c:crosses val="autoZero"/>
        <c:auto val="1"/>
        <c:lblAlgn val="ctr"/>
        <c:lblOffset val="100"/>
        <c:noMultiLvlLbl val="0"/>
      </c:catAx>
      <c:valAx>
        <c:axId val="412031408"/>
        <c:scaling>
          <c:orientation val="minMax"/>
          <c:max val="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altLang="ja-JP"/>
                  <a:t>ng/ml</a:t>
                </a:r>
                <a:endParaRPr lang="ja-JP" alt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ja-JP"/>
          </a:p>
        </c:txPr>
        <c:crossAx val="425114760"/>
        <c:crosses val="autoZero"/>
        <c:crossBetween val="between"/>
        <c:majorUnit val="1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649796296296296"/>
          <c:y val="8.3661111111111117E-2"/>
          <c:w val="0.86763166666666669"/>
          <c:h val="0.809071111111111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H$4</c:f>
              <c:strCache>
                <c:ptCount val="1"/>
                <c:pt idx="0">
                  <c:v>IPA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A5F-4B28-AF93-F7C36069FE71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A5F-4B28-AF93-F7C36069FE71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A5F-4B28-AF93-F7C36069FE71}"/>
              </c:ext>
            </c:extLst>
          </c:dPt>
          <c:dPt>
            <c:idx val="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A5F-4B28-AF93-F7C36069FE71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A5F-4B28-AF93-F7C36069FE71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A5F-4B28-AF93-F7C36069FE71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A5F-4B28-AF93-F7C36069FE71}"/>
              </c:ext>
            </c:extLst>
          </c:dPt>
          <c:dPt>
            <c:idx val="8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A5F-4B28-AF93-F7C36069FE71}"/>
              </c:ext>
            </c:extLst>
          </c:dPt>
          <c:dPt>
            <c:idx val="9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DA5F-4B28-AF93-F7C36069FE71}"/>
              </c:ext>
            </c:extLst>
          </c:dPt>
          <c:dPt>
            <c:idx val="10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DA5F-4B28-AF93-F7C36069FE71}"/>
              </c:ext>
            </c:extLst>
          </c:dPt>
          <c:dPt>
            <c:idx val="11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DA5F-4B28-AF93-F7C36069FE71}"/>
              </c:ext>
            </c:extLst>
          </c:dPt>
          <c:dPt>
            <c:idx val="12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DA5F-4B28-AF93-F7C36069FE71}"/>
              </c:ext>
            </c:extLst>
          </c:dPt>
          <c:dPt>
            <c:idx val="13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DA5F-4B28-AF93-F7C36069FE71}"/>
              </c:ext>
            </c:extLst>
          </c:dPt>
          <c:dPt>
            <c:idx val="14"/>
            <c:invertIfNegative val="0"/>
            <c:bubble3D val="0"/>
            <c:spPr>
              <a:pattFill prst="pct5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DA5F-4B28-AF93-F7C36069FE71}"/>
              </c:ext>
            </c:extLst>
          </c:dPt>
          <c:dPt>
            <c:idx val="15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DA5F-4B28-AF93-F7C36069FE71}"/>
              </c:ext>
            </c:extLst>
          </c:dPt>
          <c:dPt>
            <c:idx val="16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DA5F-4B28-AF93-F7C36069FE71}"/>
              </c:ext>
            </c:extLst>
          </c:dPt>
          <c:dPt>
            <c:idx val="17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DA5F-4B28-AF93-F7C36069FE71}"/>
              </c:ext>
            </c:extLst>
          </c:dPt>
          <c:dPt>
            <c:idx val="18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DA5F-4B28-AF93-F7C36069FE71}"/>
              </c:ext>
            </c:extLst>
          </c:dPt>
          <c:dPt>
            <c:idx val="19"/>
            <c:invertIfNegative val="0"/>
            <c:bubble3D val="0"/>
            <c:spPr>
              <a:pattFill prst="dkHorz">
                <a:fgClr>
                  <a:sysClr val="windowText" lastClr="000000"/>
                </a:fgClr>
                <a:bgClr>
                  <a:sysClr val="window" lastClr="FFFFFF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DA5F-4B28-AF93-F7C36069FE71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L$5:$L$24</c:f>
                <c:numCache>
                  <c:formatCode>General</c:formatCode>
                  <c:ptCount val="20"/>
                  <c:pt idx="0">
                    <c:v>0.55006603954161848</c:v>
                  </c:pt>
                  <c:pt idx="1">
                    <c:v>1.2966048072398162</c:v>
                  </c:pt>
                  <c:pt idx="2">
                    <c:v>0.84209901065869908</c:v>
                  </c:pt>
                  <c:pt idx="3">
                    <c:v>0.68589378588549887</c:v>
                  </c:pt>
                  <c:pt idx="4">
                    <c:v>0.31344452899815567</c:v>
                  </c:pt>
                  <c:pt idx="5">
                    <c:v>0.7956192692741505</c:v>
                  </c:pt>
                  <c:pt idx="6">
                    <c:v>0.30596402129160682</c:v>
                  </c:pt>
                  <c:pt idx="7">
                    <c:v>1.0877623001902188</c:v>
                  </c:pt>
                  <c:pt idx="8">
                    <c:v>0.19770123083541574</c:v>
                  </c:pt>
                  <c:pt idx="9">
                    <c:v>1.4435126690012119</c:v>
                  </c:pt>
                  <c:pt idx="10">
                    <c:v>0.79908924709677098</c:v>
                  </c:pt>
                  <c:pt idx="11">
                    <c:v>0.86771975904354515</c:v>
                  </c:pt>
                  <c:pt idx="12">
                    <c:v>0.25497470599632283</c:v>
                  </c:pt>
                  <c:pt idx="13">
                    <c:v>0.36592681484548978</c:v>
                  </c:pt>
                  <c:pt idx="14">
                    <c:v>0.63195145050260526</c:v>
                  </c:pt>
                  <c:pt idx="15">
                    <c:v>0.652720582939467</c:v>
                  </c:pt>
                  <c:pt idx="16">
                    <c:v>0.57405562719078695</c:v>
                  </c:pt>
                  <c:pt idx="17">
                    <c:v>0.4548160150503634</c:v>
                  </c:pt>
                  <c:pt idx="18">
                    <c:v>0.42551811016798957</c:v>
                  </c:pt>
                  <c:pt idx="19">
                    <c:v>0.80453542557736168</c:v>
                  </c:pt>
                </c:numCache>
              </c:numRef>
            </c:plus>
            <c:minus>
              <c:numRef>
                <c:f>Sheet2!$L$5:$L$24</c:f>
                <c:numCache>
                  <c:formatCode>General</c:formatCode>
                  <c:ptCount val="20"/>
                  <c:pt idx="0">
                    <c:v>0.55006603954161848</c:v>
                  </c:pt>
                  <c:pt idx="1">
                    <c:v>1.2966048072398162</c:v>
                  </c:pt>
                  <c:pt idx="2">
                    <c:v>0.84209901065869908</c:v>
                  </c:pt>
                  <c:pt idx="3">
                    <c:v>0.68589378588549887</c:v>
                  </c:pt>
                  <c:pt idx="4">
                    <c:v>0.31344452899815567</c:v>
                  </c:pt>
                  <c:pt idx="5">
                    <c:v>0.7956192692741505</c:v>
                  </c:pt>
                  <c:pt idx="6">
                    <c:v>0.30596402129160682</c:v>
                  </c:pt>
                  <c:pt idx="7">
                    <c:v>1.0877623001902188</c:v>
                  </c:pt>
                  <c:pt idx="8">
                    <c:v>0.19770123083541574</c:v>
                  </c:pt>
                  <c:pt idx="9">
                    <c:v>1.4435126690012119</c:v>
                  </c:pt>
                  <c:pt idx="10">
                    <c:v>0.79908924709677098</c:v>
                  </c:pt>
                  <c:pt idx="11">
                    <c:v>0.86771975904354515</c:v>
                  </c:pt>
                  <c:pt idx="12">
                    <c:v>0.25497470599632283</c:v>
                  </c:pt>
                  <c:pt idx="13">
                    <c:v>0.36592681484548978</c:v>
                  </c:pt>
                  <c:pt idx="14">
                    <c:v>0.63195145050260526</c:v>
                  </c:pt>
                  <c:pt idx="15">
                    <c:v>0.652720582939467</c:v>
                  </c:pt>
                  <c:pt idx="16">
                    <c:v>0.57405562719078695</c:v>
                  </c:pt>
                  <c:pt idx="17">
                    <c:v>0.4548160150503634</c:v>
                  </c:pt>
                  <c:pt idx="18">
                    <c:v>0.42551811016798957</c:v>
                  </c:pt>
                  <c:pt idx="19">
                    <c:v>0.80453542557736168</c:v>
                  </c:pt>
                </c:numCache>
              </c:numRef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2!$N$5:$N$24</c:f>
              <c:numCache>
                <c:formatCode>General</c:formatCode>
                <c:ptCount val="20"/>
              </c:numCache>
            </c:numRef>
          </c:cat>
          <c:val>
            <c:numRef>
              <c:f>Sheet2!$H$5:$H$24</c:f>
              <c:numCache>
                <c:formatCode>0.00</c:formatCode>
                <c:ptCount val="20"/>
                <c:pt idx="0">
                  <c:v>3.7808836053410935</c:v>
                </c:pt>
                <c:pt idx="1">
                  <c:v>3.1737999913816144</c:v>
                </c:pt>
                <c:pt idx="2">
                  <c:v>2.4737670580751328</c:v>
                </c:pt>
                <c:pt idx="3">
                  <c:v>2.385213689328042</c:v>
                </c:pt>
                <c:pt idx="4">
                  <c:v>2.5733238332400452</c:v>
                </c:pt>
                <c:pt idx="5">
                  <c:v>2.8075418006125861</c:v>
                </c:pt>
                <c:pt idx="6">
                  <c:v>2.5599306925364793</c:v>
                </c:pt>
                <c:pt idx="7">
                  <c:v>2.7928239593002102</c:v>
                </c:pt>
                <c:pt idx="8">
                  <c:v>2.8104550864538731</c:v>
                </c:pt>
                <c:pt idx="9">
                  <c:v>2.6591025559748669</c:v>
                </c:pt>
                <c:pt idx="10">
                  <c:v>2.8522930617458853</c:v>
                </c:pt>
                <c:pt idx="11">
                  <c:v>2.5612986001106952</c:v>
                </c:pt>
                <c:pt idx="12">
                  <c:v>2.3839306754112819</c:v>
                </c:pt>
                <c:pt idx="13">
                  <c:v>2.7145412429260056</c:v>
                </c:pt>
                <c:pt idx="14">
                  <c:v>2.523626933393281</c:v>
                </c:pt>
                <c:pt idx="15">
                  <c:v>2.4790529482989907</c:v>
                </c:pt>
                <c:pt idx="16">
                  <c:v>2.5972748943435944</c:v>
                </c:pt>
                <c:pt idx="17">
                  <c:v>3.0407426528683636</c:v>
                </c:pt>
                <c:pt idx="18">
                  <c:v>2.2688725369044049</c:v>
                </c:pt>
                <c:pt idx="19">
                  <c:v>2.88462972234871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DA5F-4B28-AF93-F7C36069FE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-27"/>
        <c:axId val="412032192"/>
        <c:axId val="424388768"/>
      </c:barChart>
      <c:catAx>
        <c:axId val="4120321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ja-JP"/>
          </a:p>
        </c:txPr>
        <c:crossAx val="424388768"/>
        <c:crosses val="autoZero"/>
        <c:auto val="1"/>
        <c:lblAlgn val="ctr"/>
        <c:lblOffset val="100"/>
        <c:noMultiLvlLbl val="0"/>
      </c:catAx>
      <c:valAx>
        <c:axId val="424388768"/>
        <c:scaling>
          <c:orientation val="minMax"/>
          <c:max val="6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altLang="ja-JP"/>
                  <a:t>ng/ml</a:t>
                </a:r>
                <a:endParaRPr lang="ja-JP" alt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ja-JP"/>
          </a:p>
        </c:txPr>
        <c:crossAx val="412032192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43" indent="0" algn="ctr">
              <a:buNone/>
              <a:defRPr sz="1499"/>
            </a:lvl2pPr>
            <a:lvl3pPr marL="685685" indent="0" algn="ctr">
              <a:buNone/>
              <a:defRPr sz="1351"/>
            </a:lvl3pPr>
            <a:lvl4pPr marL="1028527" indent="0" algn="ctr">
              <a:buNone/>
              <a:defRPr sz="1200"/>
            </a:lvl4pPr>
            <a:lvl5pPr marL="1371372" indent="0" algn="ctr">
              <a:buNone/>
              <a:defRPr sz="1200"/>
            </a:lvl5pPr>
            <a:lvl6pPr marL="1714213" indent="0" algn="ctr">
              <a:buNone/>
              <a:defRPr sz="1200"/>
            </a:lvl6pPr>
            <a:lvl7pPr marL="2057056" indent="0" algn="ctr">
              <a:buNone/>
              <a:defRPr sz="1200"/>
            </a:lvl7pPr>
            <a:lvl8pPr marL="2399899" indent="0" algn="ctr">
              <a:buNone/>
              <a:defRPr sz="1200"/>
            </a:lvl8pPr>
            <a:lvl9pPr marL="274274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9649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3381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750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335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20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20" y="6629232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43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685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5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37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2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0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8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7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6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3813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5" y="527406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3" indent="0">
              <a:buNone/>
              <a:defRPr sz="1499" b="1"/>
            </a:lvl2pPr>
            <a:lvl3pPr marL="685685" indent="0">
              <a:buNone/>
              <a:defRPr sz="1351" b="1"/>
            </a:lvl3pPr>
            <a:lvl4pPr marL="1028527" indent="0">
              <a:buNone/>
              <a:defRPr sz="1200" b="1"/>
            </a:lvl4pPr>
            <a:lvl5pPr marL="1371372" indent="0">
              <a:buNone/>
              <a:defRPr sz="1200" b="1"/>
            </a:lvl5pPr>
            <a:lvl6pPr marL="1714213" indent="0">
              <a:buNone/>
              <a:defRPr sz="1200" b="1"/>
            </a:lvl6pPr>
            <a:lvl7pPr marL="2057056" indent="0">
              <a:buNone/>
              <a:defRPr sz="1200" b="1"/>
            </a:lvl7pPr>
            <a:lvl8pPr marL="2399899" indent="0">
              <a:buNone/>
              <a:defRPr sz="1200" b="1"/>
            </a:lvl8pPr>
            <a:lvl9pPr marL="274274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3" indent="0">
              <a:buNone/>
              <a:defRPr sz="1499" b="1"/>
            </a:lvl2pPr>
            <a:lvl3pPr marL="685685" indent="0">
              <a:buNone/>
              <a:defRPr sz="1351" b="1"/>
            </a:lvl3pPr>
            <a:lvl4pPr marL="1028527" indent="0">
              <a:buNone/>
              <a:defRPr sz="1200" b="1"/>
            </a:lvl4pPr>
            <a:lvl5pPr marL="1371372" indent="0">
              <a:buNone/>
              <a:defRPr sz="1200" b="1"/>
            </a:lvl5pPr>
            <a:lvl6pPr marL="1714213" indent="0">
              <a:buNone/>
              <a:defRPr sz="1200" b="1"/>
            </a:lvl6pPr>
            <a:lvl7pPr marL="2057056" indent="0">
              <a:buNone/>
              <a:defRPr sz="1200" b="1"/>
            </a:lvl7pPr>
            <a:lvl8pPr marL="2399899" indent="0">
              <a:buNone/>
              <a:defRPr sz="1200" b="1"/>
            </a:lvl8pPr>
            <a:lvl9pPr marL="274274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604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5195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2061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7" y="1426288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3" indent="0">
              <a:buNone/>
              <a:defRPr sz="1050"/>
            </a:lvl2pPr>
            <a:lvl3pPr marL="685685" indent="0">
              <a:buNone/>
              <a:defRPr sz="900"/>
            </a:lvl3pPr>
            <a:lvl4pPr marL="1028527" indent="0">
              <a:buNone/>
              <a:defRPr sz="750"/>
            </a:lvl4pPr>
            <a:lvl5pPr marL="1371372" indent="0">
              <a:buNone/>
              <a:defRPr sz="750"/>
            </a:lvl5pPr>
            <a:lvl6pPr marL="1714213" indent="0">
              <a:buNone/>
              <a:defRPr sz="750"/>
            </a:lvl6pPr>
            <a:lvl7pPr marL="2057056" indent="0">
              <a:buNone/>
              <a:defRPr sz="750"/>
            </a:lvl7pPr>
            <a:lvl8pPr marL="2399899" indent="0">
              <a:buNone/>
              <a:defRPr sz="750"/>
            </a:lvl8pPr>
            <a:lvl9pPr marL="274274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1955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7" y="1426288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43" indent="0">
              <a:buNone/>
              <a:defRPr sz="2100"/>
            </a:lvl2pPr>
            <a:lvl3pPr marL="685685" indent="0">
              <a:buNone/>
              <a:defRPr sz="1800"/>
            </a:lvl3pPr>
            <a:lvl4pPr marL="1028527" indent="0">
              <a:buNone/>
              <a:defRPr sz="1499"/>
            </a:lvl4pPr>
            <a:lvl5pPr marL="1371372" indent="0">
              <a:buNone/>
              <a:defRPr sz="1499"/>
            </a:lvl5pPr>
            <a:lvl6pPr marL="1714213" indent="0">
              <a:buNone/>
              <a:defRPr sz="1499"/>
            </a:lvl6pPr>
            <a:lvl7pPr marL="2057056" indent="0">
              <a:buNone/>
              <a:defRPr sz="1499"/>
            </a:lvl7pPr>
            <a:lvl8pPr marL="2399899" indent="0">
              <a:buNone/>
              <a:defRPr sz="1499"/>
            </a:lvl8pPr>
            <a:lvl9pPr marL="2742740" indent="0">
              <a:buNone/>
              <a:defRPr sz="1499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3" indent="0">
              <a:buNone/>
              <a:defRPr sz="1050"/>
            </a:lvl2pPr>
            <a:lvl3pPr marL="685685" indent="0">
              <a:buNone/>
              <a:defRPr sz="900"/>
            </a:lvl3pPr>
            <a:lvl4pPr marL="1028527" indent="0">
              <a:buNone/>
              <a:defRPr sz="750"/>
            </a:lvl4pPr>
            <a:lvl5pPr marL="1371372" indent="0">
              <a:buNone/>
              <a:defRPr sz="750"/>
            </a:lvl5pPr>
            <a:lvl6pPr marL="1714213" indent="0">
              <a:buNone/>
              <a:defRPr sz="750"/>
            </a:lvl6pPr>
            <a:lvl7pPr marL="2057056" indent="0">
              <a:buNone/>
              <a:defRPr sz="750"/>
            </a:lvl7pPr>
            <a:lvl8pPr marL="2399899" indent="0">
              <a:buNone/>
              <a:defRPr sz="750"/>
            </a:lvl8pPr>
            <a:lvl9pPr marL="274274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218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2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2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2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4FED98-A87E-408E-A286-A28530AD2202}" type="datetimeFigureOut">
              <a:rPr kumimoji="1" lang="ja-JP" altLang="en-US" smtClean="0"/>
              <a:t>2019/9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7" y="9181402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2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4765E9-DB39-4804-89FA-A8B362743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8635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685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22" indent="-171422" algn="l" defTabSz="685685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65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06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199949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791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634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478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321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162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43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685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527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372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213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056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399899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740" algn="l" defTabSz="685685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190501" y="1429518"/>
            <a:ext cx="6129002" cy="6764173"/>
            <a:chOff x="1" y="1429518"/>
            <a:chExt cx="6129002" cy="6764173"/>
          </a:xfrm>
        </p:grpSpPr>
        <p:graphicFrame>
          <p:nvGraphicFramePr>
            <p:cNvPr id="21" name="グラフ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30454166"/>
                </p:ext>
              </p:extLst>
            </p:nvPr>
          </p:nvGraphicFramePr>
          <p:xfrm>
            <a:off x="748054" y="5339545"/>
            <a:ext cx="5361901" cy="28541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グラフ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49755876"/>
                </p:ext>
              </p:extLst>
            </p:nvPr>
          </p:nvGraphicFramePr>
          <p:xfrm>
            <a:off x="729002" y="3842117"/>
            <a:ext cx="5400001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グラフ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39213284"/>
                </p:ext>
              </p:extLst>
            </p:nvPr>
          </p:nvGraphicFramePr>
          <p:xfrm>
            <a:off x="729001" y="2344686"/>
            <a:ext cx="5400001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右中かっこ 9"/>
            <p:cNvSpPr/>
            <p:nvPr/>
          </p:nvSpPr>
          <p:spPr>
            <a:xfrm rot="16200000" flipV="1">
              <a:off x="2600980" y="1160821"/>
              <a:ext cx="158292" cy="2268000"/>
            </a:xfrm>
            <a:prstGeom prst="righ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094870" y="1740823"/>
              <a:ext cx="11705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 smtClean="0">
                  <a:latin typeface="Arial Narrow" panose="020B0606020202030204" pitchFamily="34" charset="0"/>
                </a:rPr>
                <a:t>infant-HRB</a:t>
              </a:r>
              <a:endParaRPr lang="ja-JP" altLang="en-US" b="1" dirty="0">
                <a:latin typeface="Arial Narrow" panose="020B0606020202030204" pitchFamily="34" charset="0"/>
              </a:endParaRPr>
            </a:p>
          </p:txBody>
        </p:sp>
        <p:sp>
          <p:nvSpPr>
            <p:cNvPr id="12" name="右中かっこ 11"/>
            <p:cNvSpPr/>
            <p:nvPr/>
          </p:nvSpPr>
          <p:spPr>
            <a:xfrm rot="16200000" flipV="1">
              <a:off x="4244417" y="1808822"/>
              <a:ext cx="158292" cy="972000"/>
            </a:xfrm>
            <a:prstGeom prst="righ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769566" y="1740823"/>
              <a:ext cx="1107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 smtClean="0">
                  <a:latin typeface="Arial Narrow" panose="020B0606020202030204" pitchFamily="34" charset="0"/>
                </a:rPr>
                <a:t>adult-HRB</a:t>
              </a:r>
              <a:endParaRPr lang="ja-JP" altLang="en-US" b="1" dirty="0">
                <a:latin typeface="Arial Narrow" panose="020B0606020202030204" pitchFamily="34" charset="0"/>
              </a:endParaRPr>
            </a:p>
          </p:txBody>
        </p:sp>
        <p:sp>
          <p:nvSpPr>
            <p:cNvPr id="14" name="右中かっこ 13"/>
            <p:cNvSpPr/>
            <p:nvPr/>
          </p:nvSpPr>
          <p:spPr>
            <a:xfrm rot="16200000" flipV="1">
              <a:off x="5318773" y="1718821"/>
              <a:ext cx="158292" cy="1151999"/>
            </a:xfrm>
            <a:prstGeom prst="righ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896825" y="1740823"/>
              <a:ext cx="10021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Arial Narrow" panose="020B0606020202030204" pitchFamily="34" charset="0"/>
                </a:rPr>
                <a:t>non-HRB</a:t>
              </a:r>
              <a:endParaRPr lang="ja-JP" altLang="en-US" b="1" dirty="0">
                <a:latin typeface="Arial Narrow" panose="020B060602020203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80347" y="2338220"/>
              <a:ext cx="3722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Arial Narrow" panose="020B0606020202030204" pitchFamily="34" charset="0"/>
                </a:rPr>
                <a:t>a)</a:t>
              </a:r>
              <a:endParaRPr lang="ja-JP" altLang="en-US" sz="2000" b="1" dirty="0">
                <a:latin typeface="Arial Narrow" panose="020B060602020203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480347" y="3855560"/>
              <a:ext cx="38343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Arial Narrow" panose="020B0606020202030204" pitchFamily="34" charset="0"/>
                </a:rPr>
                <a:t>b)</a:t>
              </a:r>
              <a:endParaRPr lang="ja-JP" altLang="en-US" sz="2000" b="1" dirty="0">
                <a:latin typeface="Arial Narrow" panose="020B060602020203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480348" y="5372901"/>
              <a:ext cx="3722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Arial Narrow" panose="020B0606020202030204" pitchFamily="34" charset="0"/>
                </a:rPr>
                <a:t>c)</a:t>
              </a:r>
              <a:endParaRPr lang="ja-JP" altLang="en-US" sz="2000" b="1" dirty="0">
                <a:latin typeface="Arial Narrow" panose="020B0606020202030204" pitchFamily="34" charset="0"/>
              </a:endParaRPr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1" y="1429518"/>
              <a:ext cx="1335622" cy="4617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1" b="1" dirty="0">
                  <a:latin typeface="Arial Narrow" panose="020B0606020202030204" pitchFamily="34" charset="0"/>
                </a:rPr>
                <a:t>Figure </a:t>
              </a:r>
              <a:r>
                <a:rPr lang="en-US" altLang="ja-JP" sz="2401" b="1" dirty="0" smtClean="0">
                  <a:latin typeface="Arial Narrow" panose="020B0606020202030204" pitchFamily="34" charset="0"/>
                </a:rPr>
                <a:t>S1</a:t>
              </a:r>
              <a:endParaRPr lang="ja-JP" altLang="en-US" sz="2401" b="1" dirty="0">
                <a:latin typeface="Arial Narrow" panose="020B0606020202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7986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2</TotalTime>
  <Words>14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Arial Narrow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</dc:creator>
  <cp:lastModifiedBy>森永乳業㈱</cp:lastModifiedBy>
  <cp:revision>25</cp:revision>
  <dcterms:created xsi:type="dcterms:W3CDTF">2018-12-26T05:05:55Z</dcterms:created>
  <dcterms:modified xsi:type="dcterms:W3CDTF">2019-09-11T00:41:10Z</dcterms:modified>
</cp:coreProperties>
</file>